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453" r:id="rId2"/>
    <p:sldId id="451" r:id="rId3"/>
    <p:sldId id="452" r:id="rId4"/>
  </p:sldIdLst>
  <p:sldSz cx="7556500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458" autoAdjust="0"/>
    <p:restoredTop sz="94660"/>
  </p:normalViewPr>
  <p:slideViewPr>
    <p:cSldViewPr snapToGrid="0">
      <p:cViewPr>
        <p:scale>
          <a:sx n="50" d="100"/>
          <a:sy n="50" d="100"/>
        </p:scale>
        <p:origin x="2597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ata%20from%20meenu%20pd\HMM\real%20time%20data%20arabidopsis%20ckx\CKX2%2026%20MAY%202022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AD$32:$AD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7</c:v>
                  </c:pt>
                  <c:pt idx="2">
                    <c:v>0.53</c:v>
                  </c:pt>
                  <c:pt idx="3">
                    <c:v>1.2</c:v>
                  </c:pt>
                </c:numCache>
              </c:numRef>
            </c:plus>
            <c:minus>
              <c:numRef>
                <c:f>Sheet1!$AD$32:$AD$3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7</c:v>
                  </c:pt>
                  <c:pt idx="2">
                    <c:v>0.53</c:v>
                  </c:pt>
                  <c:pt idx="3">
                    <c:v>1.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B$32:$AB$35</c:f>
              <c:strCache>
                <c:ptCount val="4"/>
                <c:pt idx="0">
                  <c:v>WT</c:v>
                </c:pt>
                <c:pt idx="1">
                  <c:v>L2</c:v>
                </c:pt>
                <c:pt idx="2">
                  <c:v>L37</c:v>
                </c:pt>
                <c:pt idx="3">
                  <c:v>L41</c:v>
                </c:pt>
              </c:strCache>
            </c:strRef>
          </c:cat>
          <c:val>
            <c:numRef>
              <c:f>Sheet1!$AC$32:$AC$35</c:f>
              <c:numCache>
                <c:formatCode>0.0</c:formatCode>
                <c:ptCount val="4"/>
                <c:pt idx="0">
                  <c:v>1</c:v>
                </c:pt>
                <c:pt idx="1">
                  <c:v>16</c:v>
                </c:pt>
                <c:pt idx="2">
                  <c:v>7.3</c:v>
                </c:pt>
                <c:pt idx="3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8E-4A84-8CD2-B914DFDB95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59633968"/>
        <c:axId val="959622928"/>
      </c:barChart>
      <c:catAx>
        <c:axId val="959633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9622928"/>
        <c:crosses val="autoZero"/>
        <c:auto val="1"/>
        <c:lblAlgn val="ctr"/>
        <c:lblOffset val="100"/>
        <c:noMultiLvlLbl val="0"/>
      </c:catAx>
      <c:valAx>
        <c:axId val="9596229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I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transcript levels</a:t>
                </a:r>
              </a:p>
            </c:rich>
          </c:tx>
          <c:layout>
            <c:manualLayout>
              <c:xMode val="edge"/>
              <c:yMode val="edge"/>
              <c:x val="7.5727693945630498E-3"/>
              <c:y val="0.26646981627296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9633968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738" y="1749795"/>
            <a:ext cx="6423025" cy="3722335"/>
          </a:xfrm>
        </p:spPr>
        <p:txBody>
          <a:bodyPr anchor="b"/>
          <a:lstStyle>
            <a:lvl1pPr algn="ctr">
              <a:defRPr sz="49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563" y="5615678"/>
            <a:ext cx="5667375" cy="2581379"/>
          </a:xfrm>
        </p:spPr>
        <p:txBody>
          <a:bodyPr/>
          <a:lstStyle>
            <a:lvl1pPr marL="0" indent="0" algn="ctr">
              <a:buNone/>
              <a:defRPr sz="1983"/>
            </a:lvl1pPr>
            <a:lvl2pPr marL="377830" indent="0" algn="ctr">
              <a:buNone/>
              <a:defRPr sz="1653"/>
            </a:lvl2pPr>
            <a:lvl3pPr marL="755660" indent="0" algn="ctr">
              <a:buNone/>
              <a:defRPr sz="1488"/>
            </a:lvl3pPr>
            <a:lvl4pPr marL="1133490" indent="0" algn="ctr">
              <a:buNone/>
              <a:defRPr sz="1322"/>
            </a:lvl4pPr>
            <a:lvl5pPr marL="1511320" indent="0" algn="ctr">
              <a:buNone/>
              <a:defRPr sz="1322"/>
            </a:lvl5pPr>
            <a:lvl6pPr marL="1889150" indent="0" algn="ctr">
              <a:buNone/>
              <a:defRPr sz="1322"/>
            </a:lvl6pPr>
            <a:lvl7pPr marL="2266980" indent="0" algn="ctr">
              <a:buNone/>
              <a:defRPr sz="1322"/>
            </a:lvl7pPr>
            <a:lvl8pPr marL="2644811" indent="0" algn="ctr">
              <a:buNone/>
              <a:defRPr sz="1322"/>
            </a:lvl8pPr>
            <a:lvl9pPr marL="3022641" indent="0" algn="ctr">
              <a:buNone/>
              <a:defRPr sz="132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4146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8997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7621" y="569240"/>
            <a:ext cx="1629370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510" y="569240"/>
            <a:ext cx="4793655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24184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43455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574" y="2665532"/>
            <a:ext cx="6517481" cy="4447496"/>
          </a:xfrm>
        </p:spPr>
        <p:txBody>
          <a:bodyPr anchor="b"/>
          <a:lstStyle>
            <a:lvl1pPr>
              <a:defRPr sz="49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574" y="7155103"/>
            <a:ext cx="6517481" cy="2338833"/>
          </a:xfrm>
        </p:spPr>
        <p:txBody>
          <a:bodyPr/>
          <a:lstStyle>
            <a:lvl1pPr marL="0" indent="0">
              <a:buNone/>
              <a:defRPr sz="1983">
                <a:solidFill>
                  <a:schemeClr val="tx1"/>
                </a:solidFill>
              </a:defRPr>
            </a:lvl1pPr>
            <a:lvl2pPr marL="377830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660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49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4pPr>
            <a:lvl5pPr marL="151132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5pPr>
            <a:lvl6pPr marL="188915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6pPr>
            <a:lvl7pPr marL="226698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7pPr>
            <a:lvl8pPr marL="264481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8pPr>
            <a:lvl9pPr marL="302264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164122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509" y="2846200"/>
            <a:ext cx="3211513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5478" y="2846200"/>
            <a:ext cx="3211513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688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569242"/>
            <a:ext cx="6517481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495" y="2620980"/>
            <a:ext cx="3196753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495" y="3905482"/>
            <a:ext cx="3196753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5478" y="2620980"/>
            <a:ext cx="3212497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5478" y="3905482"/>
            <a:ext cx="321249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96771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63853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7361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2497" y="1539425"/>
            <a:ext cx="3825478" cy="7598117"/>
          </a:xfrm>
        </p:spPr>
        <p:txBody>
          <a:bodyPr/>
          <a:lstStyle>
            <a:lvl1pPr>
              <a:defRPr sz="2644"/>
            </a:lvl1pPr>
            <a:lvl2pPr>
              <a:defRPr sz="2314"/>
            </a:lvl2pPr>
            <a:lvl3pPr>
              <a:defRPr sz="1983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55958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2497" y="1539425"/>
            <a:ext cx="3825478" cy="7598117"/>
          </a:xfrm>
        </p:spPr>
        <p:txBody>
          <a:bodyPr anchor="t"/>
          <a:lstStyle>
            <a:lvl1pPr marL="0" indent="0">
              <a:buNone/>
              <a:defRPr sz="2644"/>
            </a:lvl1pPr>
            <a:lvl2pPr marL="377830" indent="0">
              <a:buNone/>
              <a:defRPr sz="2314"/>
            </a:lvl2pPr>
            <a:lvl3pPr marL="755660" indent="0">
              <a:buNone/>
              <a:defRPr sz="1983"/>
            </a:lvl3pPr>
            <a:lvl4pPr marL="1133490" indent="0">
              <a:buNone/>
              <a:defRPr sz="1653"/>
            </a:lvl4pPr>
            <a:lvl5pPr marL="1511320" indent="0">
              <a:buNone/>
              <a:defRPr sz="1653"/>
            </a:lvl5pPr>
            <a:lvl6pPr marL="1889150" indent="0">
              <a:buNone/>
              <a:defRPr sz="1653"/>
            </a:lvl6pPr>
            <a:lvl7pPr marL="2266980" indent="0">
              <a:buNone/>
              <a:defRPr sz="1653"/>
            </a:lvl7pPr>
            <a:lvl8pPr marL="2644811" indent="0">
              <a:buNone/>
              <a:defRPr sz="1653"/>
            </a:lvl8pPr>
            <a:lvl9pPr marL="3022641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0998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510" y="569242"/>
            <a:ext cx="6517481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510" y="2846200"/>
            <a:ext cx="6517481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509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A0038C-34F7-43AC-93F6-8A7729F4219A}" type="datetimeFigureOut">
              <a:rPr lang="en-IN" smtClean="0"/>
              <a:t>01-04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3091" y="9909729"/>
            <a:ext cx="2550319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6778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A934B-C3FC-411C-A68F-25395D988EC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07290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660" rtl="0" eaLnBrk="1" latinLnBrk="0" hangingPunct="1">
        <a:lnSpc>
          <a:spcPct val="90000"/>
        </a:lnSpc>
        <a:spcBef>
          <a:spcPct val="0"/>
        </a:spcBef>
        <a:buNone/>
        <a:defRPr sz="36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15" indent="-188915" algn="l" defTabSz="755660" rtl="0" eaLnBrk="1" latinLnBrk="0" hangingPunct="1">
        <a:lnSpc>
          <a:spcPct val="90000"/>
        </a:lnSpc>
        <a:spcBef>
          <a:spcPts val="826"/>
        </a:spcBef>
        <a:buFont typeface="Arial" panose="020B0604020202020204" pitchFamily="34" charset="0"/>
        <a:buChar char="•"/>
        <a:defRPr sz="2314" kern="1200">
          <a:solidFill>
            <a:schemeClr val="tx1"/>
          </a:solidFill>
          <a:latin typeface="+mn-lt"/>
          <a:ea typeface="+mn-ea"/>
          <a:cs typeface="+mn-cs"/>
        </a:defRPr>
      </a:lvl1pPr>
      <a:lvl2pPr marL="56674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3" kern="1200">
          <a:solidFill>
            <a:schemeClr val="tx1"/>
          </a:solidFill>
          <a:latin typeface="+mn-lt"/>
          <a:ea typeface="+mn-ea"/>
          <a:cs typeface="+mn-cs"/>
        </a:defRPr>
      </a:lvl2pPr>
      <a:lvl3pPr marL="94457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40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23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06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589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372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155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83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66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49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32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15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6980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4811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2641" algn="l" defTabSz="755660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F54B50E2-79DE-036B-6973-6BAD092BF458}"/>
              </a:ext>
            </a:extLst>
          </p:cNvPr>
          <p:cNvGrpSpPr/>
          <p:nvPr/>
        </p:nvGrpSpPr>
        <p:grpSpPr>
          <a:xfrm>
            <a:off x="1704162" y="1780032"/>
            <a:ext cx="3933185" cy="5230368"/>
            <a:chOff x="1704162" y="1780032"/>
            <a:chExt cx="3933185" cy="5230368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9A83942-5792-154E-8B48-D6AB583BD10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50" t="40731" r="18750" b="36839"/>
            <a:stretch/>
          </p:blipFill>
          <p:spPr>
            <a:xfrm>
              <a:off x="1968258" y="2258244"/>
              <a:ext cx="3346875" cy="669375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4FD18962-1A85-CAA3-F483-7E285080D78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55" t="41802" r="18621" b="42116"/>
            <a:stretch/>
          </p:blipFill>
          <p:spPr>
            <a:xfrm>
              <a:off x="1968259" y="3206496"/>
              <a:ext cx="3346875" cy="483572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FAD440B8-5B38-AE16-296F-60A8100E7711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55" t="41063" r="18792" b="41104"/>
            <a:stretch/>
          </p:blipFill>
          <p:spPr>
            <a:xfrm>
              <a:off x="1968269" y="4004540"/>
              <a:ext cx="3346875" cy="491538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5E72062-792D-27AB-5FB6-63649E611FF4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43" t="39426" r="18792" b="41672"/>
            <a:stretch/>
          </p:blipFill>
          <p:spPr>
            <a:xfrm>
              <a:off x="1968259" y="4732902"/>
              <a:ext cx="3346875" cy="491538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98FF3377-B02F-0201-3ECC-AFF2770B256D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82" t="38435" r="18793" b="41947"/>
            <a:stretch/>
          </p:blipFill>
          <p:spPr>
            <a:xfrm>
              <a:off x="1968259" y="5461264"/>
              <a:ext cx="3346875" cy="522585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7D3FC44-62C4-C729-090C-48F1FC4DFF38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83" t="39337" r="18707" b="42217"/>
            <a:stretch/>
          </p:blipFill>
          <p:spPr>
            <a:xfrm>
              <a:off x="1968258" y="6355800"/>
              <a:ext cx="3346875" cy="483572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FA8165AB-E849-B8C8-04B1-7DC72E8141F7}"/>
                </a:ext>
              </a:extLst>
            </p:cNvPr>
            <p:cNvSpPr/>
            <p:nvPr/>
          </p:nvSpPr>
          <p:spPr>
            <a:xfrm>
              <a:off x="1704162" y="1780032"/>
              <a:ext cx="3933185" cy="523036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799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2C76F1F-F9B1-3B61-2BCC-AA47D1ABB6A9}"/>
                </a:ext>
              </a:extLst>
            </p:cNvPr>
            <p:cNvSpPr txBox="1"/>
            <p:nvPr/>
          </p:nvSpPr>
          <p:spPr>
            <a:xfrm>
              <a:off x="3179368" y="3800354"/>
              <a:ext cx="1004233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6.A/B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71C2AC3-1FC0-807F-C0C0-B550AD551CF6}"/>
                </a:ext>
              </a:extLst>
            </p:cNvPr>
            <p:cNvSpPr txBox="1"/>
            <p:nvPr/>
          </p:nvSpPr>
          <p:spPr>
            <a:xfrm>
              <a:off x="3179368" y="2932781"/>
              <a:ext cx="1033565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7.A/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70549FC-54EB-F10A-F1F1-BD717F57C072}"/>
                </a:ext>
              </a:extLst>
            </p:cNvPr>
            <p:cNvSpPr txBox="1"/>
            <p:nvPr/>
          </p:nvSpPr>
          <p:spPr>
            <a:xfrm>
              <a:off x="3179368" y="2077651"/>
              <a:ext cx="924651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C67BE15-E1B5-C881-F0FC-2E9F1559ADB6}"/>
                </a:ext>
              </a:extLst>
            </p:cNvPr>
            <p:cNvSpPr txBox="1"/>
            <p:nvPr/>
          </p:nvSpPr>
          <p:spPr>
            <a:xfrm>
              <a:off x="3179368" y="4507932"/>
              <a:ext cx="924651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3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E92AEFB-9245-ECCC-497A-8CE64BE28430}"/>
                </a:ext>
              </a:extLst>
            </p:cNvPr>
            <p:cNvSpPr txBox="1"/>
            <p:nvPr/>
          </p:nvSpPr>
          <p:spPr>
            <a:xfrm>
              <a:off x="3179369" y="5319366"/>
              <a:ext cx="924651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4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097BD0C9-7EE9-A865-A015-7C2D4F4950AE}"/>
                </a:ext>
              </a:extLst>
            </p:cNvPr>
            <p:cNvSpPr txBox="1"/>
            <p:nvPr/>
          </p:nvSpPr>
          <p:spPr>
            <a:xfrm>
              <a:off x="3179368" y="6131549"/>
              <a:ext cx="1030992" cy="2837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CKX1.A/B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64346AC2-F2D5-E69E-4497-9F5847E252F7}"/>
              </a:ext>
            </a:extLst>
          </p:cNvPr>
          <p:cNvSpPr txBox="1"/>
          <p:nvPr/>
        </p:nvSpPr>
        <p:spPr>
          <a:xfrm>
            <a:off x="1558599" y="7257876"/>
            <a:ext cx="4738338" cy="4614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omain analysis of MiCKX depicting FAD and cytokinin binding domain</a:t>
            </a:r>
          </a:p>
        </p:txBody>
      </p:sp>
    </p:spTree>
    <p:extLst>
      <p:ext uri="{BB962C8B-B14F-4D97-AF65-F5344CB8AC3E}">
        <p14:creationId xmlns:p14="http://schemas.microsoft.com/office/powerpoint/2010/main" val="3777579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65AD10FB-27D0-C5CC-76E8-081101FC1DDC}"/>
              </a:ext>
            </a:extLst>
          </p:cNvPr>
          <p:cNvGrpSpPr/>
          <p:nvPr/>
        </p:nvGrpSpPr>
        <p:grpSpPr>
          <a:xfrm>
            <a:off x="501219" y="470872"/>
            <a:ext cx="6718852" cy="9503567"/>
            <a:chOff x="310043" y="438209"/>
            <a:chExt cx="6721675" cy="9507560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A9642B76-C323-6615-346B-FA4CE0093C34}"/>
                </a:ext>
              </a:extLst>
            </p:cNvPr>
            <p:cNvGrpSpPr/>
            <p:nvPr/>
          </p:nvGrpSpPr>
          <p:grpSpPr>
            <a:xfrm>
              <a:off x="310043" y="448374"/>
              <a:ext cx="6721675" cy="9497395"/>
              <a:chOff x="310043" y="448374"/>
              <a:chExt cx="6721675" cy="9497395"/>
            </a:xfrm>
          </p:grpSpPr>
          <p:pic>
            <p:nvPicPr>
              <p:cNvPr id="16" name="Picture 15">
                <a:extLst>
                  <a:ext uri="{FF2B5EF4-FFF2-40B4-BE49-F238E27FC236}">
                    <a16:creationId xmlns:a16="http://schemas.microsoft.com/office/drawing/2014/main" id="{6A08AF5B-5117-7C19-201A-1679808DA2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97" t="3538" r="4075" b="4149"/>
              <a:stretch/>
            </p:blipFill>
            <p:spPr>
              <a:xfrm>
                <a:off x="310044" y="448374"/>
                <a:ext cx="4536816" cy="3435531"/>
              </a:xfrm>
              <a:prstGeom prst="rect">
                <a:avLst/>
              </a:prstGeom>
            </p:spPr>
          </p:pic>
          <p:pic>
            <p:nvPicPr>
              <p:cNvPr id="14" name="Picture 13">
                <a:extLst>
                  <a:ext uri="{FF2B5EF4-FFF2-40B4-BE49-F238E27FC236}">
                    <a16:creationId xmlns:a16="http://schemas.microsoft.com/office/drawing/2014/main" id="{1795DF14-FCC6-432F-95DA-FDBE4AC37D0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97" t="3938" r="3100" b="5842"/>
              <a:stretch/>
            </p:blipFill>
            <p:spPr>
              <a:xfrm>
                <a:off x="2264030" y="3432947"/>
                <a:ext cx="4767688" cy="3435531"/>
              </a:xfrm>
              <a:prstGeom prst="rect">
                <a:avLst/>
              </a:prstGeom>
            </p:spPr>
          </p:pic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D7B31E39-D78E-0902-34E0-E4867BAC96F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187" t="4534" r="9772" b="3741"/>
              <a:stretch/>
            </p:blipFill>
            <p:spPr>
              <a:xfrm>
                <a:off x="310043" y="6510238"/>
                <a:ext cx="3997235" cy="3435531"/>
              </a:xfrm>
              <a:prstGeom prst="rect">
                <a:avLst/>
              </a:prstGeom>
            </p:spPr>
          </p:pic>
        </p:grp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7A74FC6-8476-6D26-D46E-12D32E9CDD5E}"/>
                </a:ext>
              </a:extLst>
            </p:cNvPr>
            <p:cNvSpPr txBox="1"/>
            <p:nvPr/>
          </p:nvSpPr>
          <p:spPr>
            <a:xfrm>
              <a:off x="650640" y="438209"/>
              <a:ext cx="429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7F088E0-13B3-D7C2-D37F-95AAB074485D}"/>
                </a:ext>
              </a:extLst>
            </p:cNvPr>
            <p:cNvSpPr txBox="1"/>
            <p:nvPr/>
          </p:nvSpPr>
          <p:spPr>
            <a:xfrm>
              <a:off x="3349980" y="3730016"/>
              <a:ext cx="429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8E2D514-4682-6B56-82ED-FAD380B99962}"/>
                </a:ext>
              </a:extLst>
            </p:cNvPr>
            <p:cNvSpPr txBox="1"/>
            <p:nvPr/>
          </p:nvSpPr>
          <p:spPr>
            <a:xfrm>
              <a:off x="650639" y="6417519"/>
              <a:ext cx="4298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399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E75C11F-EE4A-B072-160F-97497100BD97}"/>
              </a:ext>
            </a:extLst>
          </p:cNvPr>
          <p:cNvSpPr txBox="1"/>
          <p:nvPr/>
        </p:nvSpPr>
        <p:spPr>
          <a:xfrm>
            <a:off x="787962" y="10067119"/>
            <a:ext cx="57920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IN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 </a:t>
            </a:r>
            <a:r>
              <a:rPr lang="en-IN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ontology analysis. </a:t>
            </a:r>
            <a:r>
              <a:rPr lang="en-IN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IN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logical processes. </a:t>
            </a:r>
            <a:r>
              <a:rPr lang="en-IN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 </a:t>
            </a:r>
            <a:r>
              <a:rPr lang="en-IN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lecular processes. </a:t>
            </a:r>
            <a:r>
              <a:rPr lang="en-IN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 </a:t>
            </a:r>
            <a:r>
              <a:rPr lang="en-IN" sz="12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ular components</a:t>
            </a:r>
            <a:endParaRPr lang="en-IN" sz="12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4399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013FBD0-1D4A-C288-BEC3-8EF97DEF02A8}"/>
              </a:ext>
            </a:extLst>
          </p:cNvPr>
          <p:cNvGrpSpPr/>
          <p:nvPr/>
        </p:nvGrpSpPr>
        <p:grpSpPr>
          <a:xfrm>
            <a:off x="1322298" y="1829111"/>
            <a:ext cx="4715506" cy="2112028"/>
            <a:chOff x="50451" y="5811885"/>
            <a:chExt cx="4717487" cy="2112915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781CF7E-DC77-D522-360D-5F76397F7169}"/>
                </a:ext>
              </a:extLst>
            </p:cNvPr>
            <p:cNvGrpSpPr/>
            <p:nvPr/>
          </p:nvGrpSpPr>
          <p:grpSpPr>
            <a:xfrm>
              <a:off x="685984" y="5811885"/>
              <a:ext cx="3519409" cy="2112915"/>
              <a:chOff x="685984" y="5811885"/>
              <a:chExt cx="3519409" cy="2112915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6E488E76-AC91-FC5D-272E-D4D4DF670D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011" t="32458" r="16866" b="26432"/>
              <a:stretch/>
            </p:blipFill>
            <p:spPr>
              <a:xfrm>
                <a:off x="726831" y="6188109"/>
                <a:ext cx="3265086" cy="1736691"/>
              </a:xfrm>
              <a:prstGeom prst="rect">
                <a:avLst/>
              </a:prstGeom>
            </p:spPr>
          </p:pic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9493D2F1-8BC3-8BEF-C01C-30A4A8EDB011}"/>
                  </a:ext>
                </a:extLst>
              </p:cNvPr>
              <p:cNvGrpSpPr/>
              <p:nvPr/>
            </p:nvGrpSpPr>
            <p:grpSpPr>
              <a:xfrm>
                <a:off x="685984" y="5811885"/>
                <a:ext cx="3519409" cy="430887"/>
                <a:chOff x="685984" y="5811885"/>
                <a:chExt cx="3519409" cy="430887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44EC136B-C101-6234-F1CF-F1AF00B8ED1C}"/>
                    </a:ext>
                  </a:extLst>
                </p:cNvPr>
                <p:cNvSpPr txBox="1"/>
                <p:nvPr/>
              </p:nvSpPr>
              <p:spPr>
                <a:xfrm>
                  <a:off x="3613188" y="5811885"/>
                  <a:ext cx="592205" cy="430887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kb ladder</a:t>
                  </a:r>
                  <a:endParaRPr lang="en-IN" sz="11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0C06C5B9-21E9-9EEE-3E84-1D8E745E84F6}"/>
                    </a:ext>
                  </a:extLst>
                </p:cNvPr>
                <p:cNvSpPr txBox="1"/>
                <p:nvPr/>
              </p:nvSpPr>
              <p:spPr>
                <a:xfrm>
                  <a:off x="3065252" y="5953221"/>
                  <a:ext cx="633379" cy="26161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en-IN" sz="11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r>
                    <a:rPr lang="en-IN" sz="11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WT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05CA6D54-2BC3-800F-3F11-8E7150BC64E7}"/>
                    </a:ext>
                  </a:extLst>
                </p:cNvPr>
                <p:cNvSpPr txBox="1"/>
                <p:nvPr/>
              </p:nvSpPr>
              <p:spPr>
                <a:xfrm>
                  <a:off x="685984" y="5968610"/>
                  <a:ext cx="2636947" cy="24622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   2    3    9  15  16  18   37 38  39  41 +</a:t>
                  </a:r>
                  <a:r>
                    <a:rPr lang="en-US" sz="1000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ve</a:t>
                  </a:r>
                  <a:endParaRPr lang="en-IN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E2968D7-0A37-C437-9DDC-6E5DC48C57A6}"/>
                </a:ext>
              </a:extLst>
            </p:cNvPr>
            <p:cNvSpPr txBox="1"/>
            <p:nvPr/>
          </p:nvSpPr>
          <p:spPr>
            <a:xfrm>
              <a:off x="50451" y="6824318"/>
              <a:ext cx="6045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6 bp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D85D4E6-FE84-0F20-9A0F-0F50F4892A6D}"/>
                </a:ext>
              </a:extLst>
            </p:cNvPr>
            <p:cNvSpPr txBox="1"/>
            <p:nvPr/>
          </p:nvSpPr>
          <p:spPr>
            <a:xfrm>
              <a:off x="3991917" y="6815899"/>
              <a:ext cx="7760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00 bp</a:t>
              </a:r>
            </a:p>
          </p:txBody>
        </p:sp>
        <p:sp>
          <p:nvSpPr>
            <p:cNvPr id="6" name="Arrow: Right 5">
              <a:extLst>
                <a:ext uri="{FF2B5EF4-FFF2-40B4-BE49-F238E27FC236}">
                  <a16:creationId xmlns:a16="http://schemas.microsoft.com/office/drawing/2014/main" id="{F6323888-EC7B-8204-C070-FE804F547823}"/>
                </a:ext>
              </a:extLst>
            </p:cNvPr>
            <p:cNvSpPr/>
            <p:nvPr/>
          </p:nvSpPr>
          <p:spPr>
            <a:xfrm rot="10800000">
              <a:off x="3909291" y="6914192"/>
              <a:ext cx="162202" cy="45719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799"/>
            </a:p>
          </p:txBody>
        </p:sp>
        <p:sp>
          <p:nvSpPr>
            <p:cNvPr id="7" name="Arrow: Right 6">
              <a:extLst>
                <a:ext uri="{FF2B5EF4-FFF2-40B4-BE49-F238E27FC236}">
                  <a16:creationId xmlns:a16="http://schemas.microsoft.com/office/drawing/2014/main" id="{EF4722C4-5DC1-DDEE-B313-447CCABAC3D3}"/>
                </a:ext>
              </a:extLst>
            </p:cNvPr>
            <p:cNvSpPr/>
            <p:nvPr/>
          </p:nvSpPr>
          <p:spPr>
            <a:xfrm>
              <a:off x="583103" y="6919293"/>
              <a:ext cx="162202" cy="45719"/>
            </a:xfrm>
            <a:prstGeom prst="righ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 sz="1799" dirty="0"/>
            </a:p>
          </p:txBody>
        </p:sp>
      </p:grp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ED24C062-BE31-846A-612F-F3B07DFC22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271073"/>
              </p:ext>
            </p:extLst>
          </p:nvPr>
        </p:nvGraphicFramePr>
        <p:xfrm>
          <a:off x="1935793" y="4748277"/>
          <a:ext cx="3352714" cy="2742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F3F96BBD-6657-41B3-A2AE-C524415A755E}"/>
              </a:ext>
            </a:extLst>
          </p:cNvPr>
          <p:cNvSpPr txBox="1"/>
          <p:nvPr/>
        </p:nvSpPr>
        <p:spPr>
          <a:xfrm>
            <a:off x="1409637" y="1726161"/>
            <a:ext cx="429676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3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33FE7F5-83DB-DA49-0D6F-46999ABF7B75}"/>
              </a:ext>
            </a:extLst>
          </p:cNvPr>
          <p:cNvSpPr txBox="1"/>
          <p:nvPr/>
        </p:nvSpPr>
        <p:spPr>
          <a:xfrm>
            <a:off x="1409590" y="4748277"/>
            <a:ext cx="429676" cy="3076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399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6AAFDB9-F14A-EA6E-2601-55525A701D3C}"/>
              </a:ext>
            </a:extLst>
          </p:cNvPr>
          <p:cNvSpPr txBox="1"/>
          <p:nvPr/>
        </p:nvSpPr>
        <p:spPr>
          <a:xfrm>
            <a:off x="876757" y="7890428"/>
            <a:ext cx="59758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</a:t>
            </a:r>
            <a:r>
              <a:rPr lang="en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ransgenic confirmation of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CKX4 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verexpression lines in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rabidopsis thaliana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Col-0 Wild type. 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enomic DNA confirmation using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CKX4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gene-specific primers. </a:t>
            </a:r>
            <a:r>
              <a:rPr lang="en-IN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Relative transcript levels of </a:t>
            </a:r>
            <a:r>
              <a:rPr lang="en-IN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iCKX4</a:t>
            </a:r>
            <a:r>
              <a:rPr lang="en-IN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transgenics as compared to wild-type</a:t>
            </a:r>
            <a:endParaRPr lang="en-I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6865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9</TotalTime>
  <Words>122</Words>
  <Application>Microsoft Office PowerPoint</Application>
  <PresentationFormat>Custom</PresentationFormat>
  <Paragraphs>2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chal singhal</dc:creator>
  <cp:lastModifiedBy>Chanchal singhal</cp:lastModifiedBy>
  <cp:revision>31</cp:revision>
  <dcterms:created xsi:type="dcterms:W3CDTF">2024-03-23T17:36:16Z</dcterms:created>
  <dcterms:modified xsi:type="dcterms:W3CDTF">2024-04-01T13:01:00Z</dcterms:modified>
</cp:coreProperties>
</file>